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A9ACC-9E5D-4318-9323-5493AED488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F2601D-65F9-4DD7-8552-3D4E056EA7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6203C-88B4-44CA-A7E3-A8DAC1E7A3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23D91-D64E-4069-A63B-5C6F55B3C0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-280080"/>
            <a:ext cx="8229600" cy="828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4036760" indent="0" algn="ctr">
              <a:spcBef>
                <a:spcPts val="799"/>
              </a:spcBef>
              <a:buNone/>
              <a:tabLst>
                <a:tab algn="l" pos="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6D5B5-BDB9-4C8B-B711-D59A8782A8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CD348-1C5F-4D40-848D-29DA46DE71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D4A9E-86EE-4C7B-9800-A91CBD5A63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3FEB2-2DA2-4CFC-B41E-6A406052B1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-1219320"/>
            <a:ext cx="8229600" cy="828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104036760" algn="ctr">
              <a:spcBef>
                <a:spcPts val="799"/>
              </a:spcBef>
              <a:tabLst>
                <a:tab algn="l" pos="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F17AC-8925-4BB4-91CD-3F1BBA7275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F6F0E-4045-425E-91CF-AB2D5E3BE2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919B2-859F-46B9-A176-FE453C4E3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FCAE2-6A7C-4204-81B8-30D06A5958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4440" indent="1016215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26120" indent="-279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18520" indent="-2239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66720" indent="-2239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14560" indent="-2239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56FAC1D3-0BAC-47ED-9CAA-2687C220AC97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Table 2" descr=""/>
          <p:cNvPicPr/>
          <p:nvPr/>
        </p:nvPicPr>
        <p:blipFill>
          <a:blip r:embed="rId1"/>
          <a:stretch/>
        </p:blipFill>
        <p:spPr>
          <a:xfrm>
            <a:off x="42840" y="438120"/>
            <a:ext cx="9009000" cy="52434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-25560" y="5732640"/>
            <a:ext cx="9169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irwise comparison of 16S rRNA gene sequence identify values (%)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icrobispor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trains. Accession numbers of gene sequences used are shown in the phylogenetic tree of Fig. S2 and in Table S2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28T09:07:46Z</dcterms:created>
  <dc:creator>VAIO</dc:creator>
  <dc:description/>
  <dc:language>en-US</dc:language>
  <cp:lastModifiedBy>Ricardo Machado</cp:lastModifiedBy>
  <cp:lastPrinted>2024-06-26T12:04:33Z</cp:lastPrinted>
  <dcterms:modified xsi:type="dcterms:W3CDTF">2024-06-26T12:04:36Z</dcterms:modified>
  <cp:revision>64</cp:revision>
  <dc:subject/>
  <dc:title>Présentation PowerPoint</dc:title>
</cp:coreProperties>
</file>